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>
        <p:scale>
          <a:sx n="120" d="100"/>
          <a:sy n="120" d="100"/>
        </p:scale>
        <p:origin x="-144" y="108"/>
      </p:cViewPr>
      <p:guideLst>
        <p:guide orient="horz" pos="2160"/>
        <p:guide pos="292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C79045-DA21-4A36-B9FF-591EB9A8921E}" type="datetimeFigureOut">
              <a:rPr lang="en-US" smtClean="0"/>
              <a:t>7/29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B5A769-8724-4883-A969-F025C39520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48520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C79045-DA21-4A36-B9FF-591EB9A8921E}" type="datetimeFigureOut">
              <a:rPr lang="en-US" smtClean="0"/>
              <a:t>7/29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B5A769-8724-4883-A969-F025C39520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18509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C79045-DA21-4A36-B9FF-591EB9A8921E}" type="datetimeFigureOut">
              <a:rPr lang="en-US" smtClean="0"/>
              <a:t>7/29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B5A769-8724-4883-A969-F025C39520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01690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C79045-DA21-4A36-B9FF-591EB9A8921E}" type="datetimeFigureOut">
              <a:rPr lang="en-US" smtClean="0"/>
              <a:t>7/29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B5A769-8724-4883-A969-F025C39520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17115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C79045-DA21-4A36-B9FF-591EB9A8921E}" type="datetimeFigureOut">
              <a:rPr lang="en-US" smtClean="0"/>
              <a:t>7/29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B5A769-8724-4883-A969-F025C39520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30350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C79045-DA21-4A36-B9FF-591EB9A8921E}" type="datetimeFigureOut">
              <a:rPr lang="en-US" smtClean="0"/>
              <a:t>7/29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B5A769-8724-4883-A969-F025C39520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34799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C79045-DA21-4A36-B9FF-591EB9A8921E}" type="datetimeFigureOut">
              <a:rPr lang="en-US" smtClean="0"/>
              <a:t>7/29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B5A769-8724-4883-A969-F025C39520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83671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C79045-DA21-4A36-B9FF-591EB9A8921E}" type="datetimeFigureOut">
              <a:rPr lang="en-US" smtClean="0"/>
              <a:t>7/29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B5A769-8724-4883-A969-F025C39520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12859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C79045-DA21-4A36-B9FF-591EB9A8921E}" type="datetimeFigureOut">
              <a:rPr lang="en-US" smtClean="0"/>
              <a:t>7/29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B5A769-8724-4883-A969-F025C39520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19690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C79045-DA21-4A36-B9FF-591EB9A8921E}" type="datetimeFigureOut">
              <a:rPr lang="en-US" smtClean="0"/>
              <a:t>7/29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B5A769-8724-4883-A969-F025C39520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64755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C79045-DA21-4A36-B9FF-591EB9A8921E}" type="datetimeFigureOut">
              <a:rPr lang="en-US" smtClean="0"/>
              <a:t>7/29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B5A769-8724-4883-A969-F025C39520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15593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C79045-DA21-4A36-B9FF-591EB9A8921E}" type="datetimeFigureOut">
              <a:rPr lang="en-US" smtClean="0"/>
              <a:t>7/29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B5A769-8724-4883-A969-F025C39520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78493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microsoft.com/office/2007/relationships/hdphoto" Target="../media/hdphoto1.wdp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985" t="11649" b="1"/>
          <a:stretch/>
        </p:blipFill>
        <p:spPr bwMode="auto">
          <a:xfrm>
            <a:off x="381000" y="914400"/>
            <a:ext cx="2743200" cy="2743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5079" b="11888"/>
          <a:stretch/>
        </p:blipFill>
        <p:spPr bwMode="auto">
          <a:xfrm>
            <a:off x="3168595" y="914400"/>
            <a:ext cx="2743201" cy="2743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8" name="Picture 4"/>
          <p:cNvPicPr>
            <a:picLocks noChangeArrowheads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r="13439" b="11477"/>
          <a:stretch/>
        </p:blipFill>
        <p:spPr bwMode="auto">
          <a:xfrm>
            <a:off x="5962651" y="914400"/>
            <a:ext cx="2743200" cy="2743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TextBox 68"/>
          <p:cNvSpPr txBox="1">
            <a:spLocks noChangeArrowheads="1"/>
          </p:cNvSpPr>
          <p:nvPr/>
        </p:nvSpPr>
        <p:spPr bwMode="auto">
          <a:xfrm>
            <a:off x="381000" y="516763"/>
            <a:ext cx="295275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37931725" indent="-37474525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sz="1200" b="1" dirty="0">
                <a:cs typeface="Arial" charset="0"/>
              </a:rPr>
              <a:t>A</a:t>
            </a:r>
          </a:p>
        </p:txBody>
      </p:sp>
      <p:sp>
        <p:nvSpPr>
          <p:cNvPr id="6" name="TextBox 82"/>
          <p:cNvSpPr txBox="1">
            <a:spLocks noChangeArrowheads="1"/>
          </p:cNvSpPr>
          <p:nvPr/>
        </p:nvSpPr>
        <p:spPr bwMode="auto">
          <a:xfrm>
            <a:off x="3141428" y="516763"/>
            <a:ext cx="295275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37931725" indent="-37474525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sz="1200" b="1" dirty="0">
                <a:cs typeface="Arial" charset="0"/>
              </a:rPr>
              <a:t>B</a:t>
            </a:r>
          </a:p>
        </p:txBody>
      </p:sp>
      <p:sp>
        <p:nvSpPr>
          <p:cNvPr id="7" name="TextBox 83"/>
          <p:cNvSpPr txBox="1">
            <a:spLocks noChangeArrowheads="1"/>
          </p:cNvSpPr>
          <p:nvPr/>
        </p:nvSpPr>
        <p:spPr bwMode="auto">
          <a:xfrm>
            <a:off x="5962651" y="516763"/>
            <a:ext cx="295275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37931725" indent="-37474525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sz="1200" b="1" dirty="0">
                <a:cs typeface="Arial" charset="0"/>
              </a:rPr>
              <a:t>C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381000" y="3810000"/>
            <a:ext cx="8324851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dditional Figure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. BIRC5 expression increases after castration in LTL-418 xenograft line.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A. BIRC5 IHC staining of LTL-418 xenograft tissue harvested before castration. The staining is nuclear ranging form medium to high intensity. B. BIRC5 staining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of LTL-418 xenograft tissue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harvested 1 week after castration. C. BIRC levels in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LTL-418 xenograft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tissue 3 weeks after castration showing high level of staining in absolute majority of nuclei.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363022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8</TotalTime>
  <Words>78</Words>
  <Application>Microsoft Office PowerPoint</Application>
  <PresentationFormat>On-screen Show (4:3)</PresentationFormat>
  <Paragraphs>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Irina Agoulnik</dc:creator>
  <cp:lastModifiedBy>Irina Agoulnik</cp:lastModifiedBy>
  <cp:revision>5</cp:revision>
  <dcterms:created xsi:type="dcterms:W3CDTF">2014-07-29T14:40:53Z</dcterms:created>
  <dcterms:modified xsi:type="dcterms:W3CDTF">2014-07-29T18:57:11Z</dcterms:modified>
</cp:coreProperties>
</file>